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902"/>
    <p:restoredTop sz="94662"/>
  </p:normalViewPr>
  <p:slideViewPr>
    <p:cSldViewPr snapToGrid="0" snapToObjects="1">
      <p:cViewPr varScale="1">
        <p:scale>
          <a:sx n="91" d="100"/>
          <a:sy n="91" d="100"/>
        </p:scale>
        <p:origin x="10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stile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C7B49-F465-2A4E-8245-59F9018E1EBC}" type="datetimeFigureOut">
              <a:rPr lang="en-US" smtClean="0"/>
              <a:t>3/2/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D985-008E-4741-BC98-735926AD870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902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C7B49-F465-2A4E-8245-59F9018E1EBC}" type="datetimeFigureOut">
              <a:rPr lang="en-US" smtClean="0"/>
              <a:t>3/2/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D985-008E-4741-BC98-735926AD870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209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stile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C7B49-F465-2A4E-8245-59F9018E1EBC}" type="datetimeFigureOut">
              <a:rPr lang="en-US" smtClean="0"/>
              <a:t>3/2/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D985-008E-4741-BC98-735926AD870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342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C7B49-F465-2A4E-8245-59F9018E1EBC}" type="datetimeFigureOut">
              <a:rPr lang="en-US" smtClean="0"/>
              <a:t>3/2/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D985-008E-4741-BC98-735926AD870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877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stile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C7B49-F465-2A4E-8245-59F9018E1EBC}" type="datetimeFigureOut">
              <a:rPr lang="en-US" smtClean="0"/>
              <a:t>3/2/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D985-008E-4741-BC98-735926AD870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907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C7B49-F465-2A4E-8245-59F9018E1EBC}" type="datetimeFigureOut">
              <a:rPr lang="en-US" smtClean="0"/>
              <a:t>3/2/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D985-008E-4741-BC98-735926AD870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469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stile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C7B49-F465-2A4E-8245-59F9018E1EBC}" type="datetimeFigureOut">
              <a:rPr lang="en-US" smtClean="0"/>
              <a:t>3/2/21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D985-008E-4741-BC98-735926AD870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30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C7B49-F465-2A4E-8245-59F9018E1EBC}" type="datetimeFigureOut">
              <a:rPr lang="en-US" smtClean="0"/>
              <a:t>3/2/21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D985-008E-4741-BC98-735926AD870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96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C7B49-F465-2A4E-8245-59F9018E1EBC}" type="datetimeFigureOut">
              <a:rPr lang="en-US" smtClean="0"/>
              <a:t>3/2/21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D985-008E-4741-BC98-735926AD870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332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stile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C7B49-F465-2A4E-8245-59F9018E1EBC}" type="datetimeFigureOut">
              <a:rPr lang="en-US" smtClean="0"/>
              <a:t>3/2/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D985-008E-4741-BC98-735926AD870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844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stile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DC7B49-F465-2A4E-8245-59F9018E1EBC}" type="datetimeFigureOut">
              <a:rPr lang="en-US" smtClean="0"/>
              <a:t>3/2/21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D985-008E-4741-BC98-735926AD870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0534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stile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DC7B49-F465-2A4E-8245-59F9018E1EBC}" type="datetimeFigureOut">
              <a:rPr lang="en-US" smtClean="0"/>
              <a:t>3/2/21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9ED985-008E-4741-BC98-735926AD870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2011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8622" y="1406449"/>
            <a:ext cx="6147581" cy="5211427"/>
          </a:xfrm>
          <a:prstGeom prst="rect">
            <a:avLst/>
          </a:prstGeom>
        </p:spPr>
      </p:pic>
      <p:sp>
        <p:nvSpPr>
          <p:cNvPr id="5" name="CasellaDiTesto 4"/>
          <p:cNvSpPr txBox="1"/>
          <p:nvPr/>
        </p:nvSpPr>
        <p:spPr>
          <a:xfrm>
            <a:off x="13406034" y="44945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  <p:sp>
        <p:nvSpPr>
          <p:cNvPr id="2" name="Rettangolo 1">
            <a:extLst>
              <a:ext uri="{FF2B5EF4-FFF2-40B4-BE49-F238E27FC236}">
                <a16:creationId xmlns:a16="http://schemas.microsoft.com/office/drawing/2014/main" id="{A2F79D8B-17AE-A141-9615-816AFB3BFB4B}"/>
              </a:ext>
            </a:extLst>
          </p:cNvPr>
          <p:cNvSpPr/>
          <p:nvPr/>
        </p:nvSpPr>
        <p:spPr>
          <a:xfrm>
            <a:off x="1" y="126285"/>
            <a:ext cx="12192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gure 2</a:t>
            </a:r>
            <a:r>
              <a:rPr lang="en-US" dirty="0"/>
              <a:t>. The CT median values and IQRs of SARS-CoV-2  RNA in group A (blue), group B (orange) </a:t>
            </a:r>
            <a:r>
              <a:rPr lang="en-US" dirty="0">
                <a:highlight>
                  <a:srgbClr val="FFFF00"/>
                </a:highlight>
              </a:rPr>
              <a:t>are not statistically different </a:t>
            </a:r>
            <a:br>
              <a:rPr lang="en-US" dirty="0"/>
            </a:br>
            <a:r>
              <a:rPr lang="en-US" dirty="0"/>
              <a:t>(Mann-Whitney U test p=0.58</a:t>
            </a:r>
            <a:r>
              <a:rPr lang="it-IT" dirty="0"/>
              <a:t> </a:t>
            </a:r>
            <a:r>
              <a:rPr lang="en-US" dirty="0"/>
              <a:t>). 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35623100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36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Utente di Microsoft Office</dc:creator>
  <cp:lastModifiedBy>silvia ricci</cp:lastModifiedBy>
  <cp:revision>3</cp:revision>
  <dcterms:created xsi:type="dcterms:W3CDTF">2021-03-02T17:23:30Z</dcterms:created>
  <dcterms:modified xsi:type="dcterms:W3CDTF">2021-03-02T21:08:07Z</dcterms:modified>
</cp:coreProperties>
</file>